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929AB-3262-4FA1-92D8-60DF6E309E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A4987-EBE3-4DE3-BF0B-E439DF2464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DE44E-A507-4AC0-B229-968E30DC56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DD4E5-0346-462D-B450-44333CE4AF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67E91-546E-4AB8-9351-C2A15DCCDF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4AA68-5FFE-4A4D-8838-11E40FFAC5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49DCE-5EDF-43E5-8B10-7E078D6D63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36DCA-C372-4065-9EC6-E55EF1894E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44A00-CB74-4841-92EB-B23B2A290D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7778E7-2ED3-40B9-8F3A-A9529235EB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5F37A-FC58-43B1-853B-B6E1FCBA59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CA38C-8352-4353-BECE-20496D28DB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48332E-E6C0-43AE-87BD-6EF89E8B677B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3"/>
          <p:cNvGrpSpPr/>
          <p:nvPr/>
        </p:nvGrpSpPr>
        <p:grpSpPr>
          <a:xfrm>
            <a:off x="611280" y="1052640"/>
            <a:ext cx="8064360" cy="3168360"/>
            <a:chOff x="611280" y="1052640"/>
            <a:chExt cx="8064360" cy="3168360"/>
          </a:xfrm>
        </p:grpSpPr>
        <p:sp>
          <p:nvSpPr>
            <p:cNvPr id="42" name="TextBox 2"/>
            <p:cNvSpPr/>
            <p:nvPr/>
          </p:nvSpPr>
          <p:spPr>
            <a:xfrm>
              <a:off x="611280" y="1052640"/>
              <a:ext cx="8064360" cy="3111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ble 1S. Sequences of Primers used for RT and Real-time PCR Analysi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MDR1     sense               5’- ATATCAGCAGCCCACATCAT-3’                                  154 bp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    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nti-sense       5’- GAAGCACTGGGATGTCCGGT-3’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XR         sense               5’-GTCAACCTACATGTTCAAAGGCATC-3’                       126 bp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    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nti-sense        5’-AATCTCAGTTGACACAGCTCGAAAG-3’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GAPDH   sense               5’- GGTATCGTGGAAGGACTCATGAC-3’                         188 bp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     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nti-sense        5’- ATGCCAGTGAGCTTCCCGTTCAG-3’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3" name="组合 1"/>
            <p:cNvGrpSpPr/>
            <p:nvPr/>
          </p:nvGrpSpPr>
          <p:grpSpPr>
            <a:xfrm>
              <a:off x="683280" y="1052640"/>
              <a:ext cx="7776360" cy="3168360"/>
              <a:chOff x="683280" y="1052640"/>
              <a:chExt cx="7776360" cy="3168360"/>
            </a:xfrm>
          </p:grpSpPr>
          <p:sp>
            <p:nvSpPr>
              <p:cNvPr id="44" name="直接连接符 5"/>
              <p:cNvSpPr/>
              <p:nvPr/>
            </p:nvSpPr>
            <p:spPr>
              <a:xfrm>
                <a:off x="683280" y="1484640"/>
                <a:ext cx="777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直接连接符 7"/>
              <p:cNvSpPr/>
              <p:nvPr/>
            </p:nvSpPr>
            <p:spPr>
              <a:xfrm>
                <a:off x="683280" y="1052640"/>
                <a:ext cx="777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直接连接符 8"/>
              <p:cNvSpPr/>
              <p:nvPr/>
            </p:nvSpPr>
            <p:spPr>
              <a:xfrm>
                <a:off x="683280" y="4221000"/>
                <a:ext cx="777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47" name="TextBox 4"/>
          <p:cNvSpPr/>
          <p:nvPr/>
        </p:nvSpPr>
        <p:spPr>
          <a:xfrm>
            <a:off x="611280" y="652320"/>
            <a:ext cx="1800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4T04:34:27Z</dcterms:created>
  <dc:creator>xufeifei</dc:creator>
  <dc:description/>
  <dc:language>en-US</dc:language>
  <cp:lastModifiedBy>ibm</cp:lastModifiedBy>
  <dcterms:modified xsi:type="dcterms:W3CDTF">2013-09-20T14:24:00Z</dcterms:modified>
  <cp:revision>7</cp:revision>
  <dc:subject/>
  <dc:title>PowerPoint 演示文稿</dc:title>
</cp:coreProperties>
</file>